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4DD949-7850-4E39-A06B-8DF21B21F46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5881C0-A480-4432-8462-096B537F39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8BA493-350C-48DB-AADA-75C769CA270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BEAD13-8667-4A99-9308-BB690A67BC9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09AE2A-AD82-47AC-8AE0-FBD1EC6625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536BB0-6C40-4B75-A4D6-C96A36C6377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C4FC11-60CC-46BA-8487-A8D70F958A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6DECED-3002-4518-AE3A-1539886541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F872A2-0F15-463E-ACA2-95CE4455EC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95DBBA-E5C3-4C8A-96CC-0CB7EA66DB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D0C2F4-C4F1-4D18-A419-1F84F55C4A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9EC645-A4D9-485C-AC20-A7B3E4BF6C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8F03902-15FE-4D9F-ACDB-929B5681FDF6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utoShape 42"/>
          <p:cNvSpPr/>
          <p:nvPr/>
        </p:nvSpPr>
        <p:spPr>
          <a:xfrm>
            <a:off x="1701720" y="942840"/>
            <a:ext cx="120600" cy="4565880"/>
          </a:xfrm>
          <a:custGeom>
            <a:avLst/>
            <a:gdLst>
              <a:gd name="textAreaLeft" fmla="*/ 17640 w 120600"/>
              <a:gd name="textAreaRight" fmla="*/ 102960 w 120600"/>
              <a:gd name="textAreaTop" fmla="*/ 17640 h 4565880"/>
              <a:gd name="textAreaBottom" fmla="*/ 4548240 h 4565880"/>
            </a:gdLst>
            <a:ahLst/>
            <a:rect l="textAreaLeft" t="textAreaTop" r="textAreaRight" b="textAreaBottom"/>
            <a:pathLst>
              <a:path w="21600" h="815400">
                <a:moveTo>
                  <a:pt x="10800" y="0"/>
                </a:moveTo>
                <a:arcTo wR="10800" hR="10800" stAng="16200000" swAng="-5400000"/>
                <a:lnTo>
                  <a:pt x="0" y="804600"/>
                </a:lnTo>
                <a:arcTo wR="10800" hR="10800" stAng="10800000" swAng="-5400000"/>
                <a:lnTo>
                  <a:pt x="10800" y="815400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AutoShape 42"/>
          <p:cNvSpPr/>
          <p:nvPr/>
        </p:nvSpPr>
        <p:spPr>
          <a:xfrm>
            <a:off x="2303640" y="942840"/>
            <a:ext cx="118800" cy="3768840"/>
          </a:xfrm>
          <a:custGeom>
            <a:avLst/>
            <a:gdLst>
              <a:gd name="textAreaLeft" fmla="*/ 17280 w 118800"/>
              <a:gd name="textAreaRight" fmla="*/ 101520 w 118800"/>
              <a:gd name="textAreaTop" fmla="*/ 17280 h 3768840"/>
              <a:gd name="textAreaBottom" fmla="*/ 3751560 h 3768840"/>
            </a:gdLst>
            <a:ahLst/>
            <a:rect l="textAreaLeft" t="textAreaTop" r="textAreaRight" b="textAreaBottom"/>
            <a:pathLst>
              <a:path w="21600" h="683239">
                <a:moveTo>
                  <a:pt x="10800" y="0"/>
                </a:moveTo>
                <a:arcTo wR="10800" hR="10800" stAng="16200000" swAng="-5400000"/>
                <a:lnTo>
                  <a:pt x="0" y="672439"/>
                </a:lnTo>
                <a:arcTo wR="10800" hR="10800" stAng="10800000" swAng="-5400000"/>
                <a:lnTo>
                  <a:pt x="10800" y="683239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AutoShape 42"/>
          <p:cNvSpPr/>
          <p:nvPr/>
        </p:nvSpPr>
        <p:spPr>
          <a:xfrm>
            <a:off x="2903400" y="942840"/>
            <a:ext cx="119160" cy="3875400"/>
          </a:xfrm>
          <a:custGeom>
            <a:avLst/>
            <a:gdLst>
              <a:gd name="textAreaLeft" fmla="*/ 17280 w 119160"/>
              <a:gd name="textAreaRight" fmla="*/ 101880 w 119160"/>
              <a:gd name="textAreaTop" fmla="*/ 17280 h 3875400"/>
              <a:gd name="textAreaBottom" fmla="*/ 3858120 h 3875400"/>
            </a:gdLst>
            <a:ahLst/>
            <a:rect l="textAreaLeft" t="textAreaTop" r="textAreaRight" b="textAreaBottom"/>
            <a:pathLst>
              <a:path w="21600" h="700439">
                <a:moveTo>
                  <a:pt x="10800" y="0"/>
                </a:moveTo>
                <a:arcTo wR="10800" hR="10800" stAng="16200000" swAng="-5400000"/>
                <a:lnTo>
                  <a:pt x="0" y="689639"/>
                </a:lnTo>
                <a:arcTo wR="10800" hR="10800" stAng="10800000" swAng="-5400000"/>
                <a:lnTo>
                  <a:pt x="10800" y="700439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AutoShape 42"/>
          <p:cNvSpPr/>
          <p:nvPr/>
        </p:nvSpPr>
        <p:spPr>
          <a:xfrm>
            <a:off x="3503520" y="942840"/>
            <a:ext cx="119160" cy="3768840"/>
          </a:xfrm>
          <a:custGeom>
            <a:avLst/>
            <a:gdLst>
              <a:gd name="textAreaLeft" fmla="*/ 17280 w 119160"/>
              <a:gd name="textAreaRight" fmla="*/ 101880 w 119160"/>
              <a:gd name="textAreaTop" fmla="*/ 17280 h 3768840"/>
              <a:gd name="textAreaBottom" fmla="*/ 3751560 h 3768840"/>
            </a:gdLst>
            <a:ahLst/>
            <a:rect l="textAreaLeft" t="textAreaTop" r="textAreaRight" b="textAreaBottom"/>
            <a:pathLst>
              <a:path w="21600" h="681181">
                <a:moveTo>
                  <a:pt x="10800" y="0"/>
                </a:moveTo>
                <a:arcTo wR="10800" hR="10800" stAng="16200000" swAng="-5400000"/>
                <a:lnTo>
                  <a:pt x="0" y="670381"/>
                </a:lnTo>
                <a:arcTo wR="10800" hR="10800" stAng="10800000" swAng="-5400000"/>
                <a:lnTo>
                  <a:pt x="10800" y="681181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5" name="组合 1287"/>
          <p:cNvGrpSpPr/>
          <p:nvPr/>
        </p:nvGrpSpPr>
        <p:grpSpPr>
          <a:xfrm>
            <a:off x="1042920" y="836640"/>
            <a:ext cx="538920" cy="4841640"/>
            <a:chOff x="1042920" y="836640"/>
            <a:chExt cx="538920" cy="4841640"/>
          </a:xfrm>
        </p:grpSpPr>
        <p:sp>
          <p:nvSpPr>
            <p:cNvPr id="46" name="直接连接符 1261"/>
            <p:cNvSpPr/>
            <p:nvPr/>
          </p:nvSpPr>
          <p:spPr>
            <a:xfrm>
              <a:off x="1042920" y="944280"/>
              <a:ext cx="0" cy="4564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直接连接符 1263"/>
            <p:cNvSpPr/>
            <p:nvPr/>
          </p:nvSpPr>
          <p:spPr>
            <a:xfrm>
              <a:off x="1042920" y="942840"/>
              <a:ext cx="1206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直接连接符 1265"/>
            <p:cNvSpPr/>
            <p:nvPr/>
          </p:nvSpPr>
          <p:spPr>
            <a:xfrm>
              <a:off x="1042920" y="1446120"/>
              <a:ext cx="120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直接连接符 1267"/>
            <p:cNvSpPr/>
            <p:nvPr/>
          </p:nvSpPr>
          <p:spPr>
            <a:xfrm>
              <a:off x="1042920" y="1990800"/>
              <a:ext cx="1206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直接连接符 1268"/>
            <p:cNvSpPr/>
            <p:nvPr/>
          </p:nvSpPr>
          <p:spPr>
            <a:xfrm>
              <a:off x="1058760" y="2520720"/>
              <a:ext cx="120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直接连接符 1269"/>
            <p:cNvSpPr/>
            <p:nvPr/>
          </p:nvSpPr>
          <p:spPr>
            <a:xfrm>
              <a:off x="1042920" y="3063960"/>
              <a:ext cx="120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直接连接符 1270"/>
            <p:cNvSpPr/>
            <p:nvPr/>
          </p:nvSpPr>
          <p:spPr>
            <a:xfrm>
              <a:off x="1042920" y="3597120"/>
              <a:ext cx="1206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直接连接符 1271"/>
            <p:cNvSpPr/>
            <p:nvPr/>
          </p:nvSpPr>
          <p:spPr>
            <a:xfrm>
              <a:off x="1042920" y="4127400"/>
              <a:ext cx="1206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直接连接符 1272"/>
            <p:cNvSpPr/>
            <p:nvPr/>
          </p:nvSpPr>
          <p:spPr>
            <a:xfrm>
              <a:off x="1042920" y="4659480"/>
              <a:ext cx="1206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直接连接符 1273"/>
            <p:cNvSpPr/>
            <p:nvPr/>
          </p:nvSpPr>
          <p:spPr>
            <a:xfrm>
              <a:off x="1042920" y="5189760"/>
              <a:ext cx="120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直接连接符 1274"/>
            <p:cNvSpPr/>
            <p:nvPr/>
          </p:nvSpPr>
          <p:spPr>
            <a:xfrm>
              <a:off x="1042920" y="5515200"/>
              <a:ext cx="1206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1276"/>
            <p:cNvSpPr/>
            <p:nvPr/>
          </p:nvSpPr>
          <p:spPr>
            <a:xfrm>
              <a:off x="1071720" y="836640"/>
              <a:ext cx="453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 M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1277"/>
            <p:cNvSpPr/>
            <p:nvPr/>
          </p:nvSpPr>
          <p:spPr>
            <a:xfrm>
              <a:off x="1069200" y="1361520"/>
              <a:ext cx="453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 M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1278"/>
            <p:cNvSpPr/>
            <p:nvPr/>
          </p:nvSpPr>
          <p:spPr>
            <a:xfrm>
              <a:off x="1064160" y="1895760"/>
              <a:ext cx="517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 M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Box 1280"/>
            <p:cNvSpPr/>
            <p:nvPr/>
          </p:nvSpPr>
          <p:spPr>
            <a:xfrm>
              <a:off x="1064160" y="2423160"/>
              <a:ext cx="517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5 M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1281"/>
            <p:cNvSpPr/>
            <p:nvPr/>
          </p:nvSpPr>
          <p:spPr>
            <a:xfrm>
              <a:off x="1064160" y="2979000"/>
              <a:ext cx="517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0 M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Box 1282"/>
            <p:cNvSpPr/>
            <p:nvPr/>
          </p:nvSpPr>
          <p:spPr>
            <a:xfrm>
              <a:off x="1064160" y="3510000"/>
              <a:ext cx="517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5 M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Box 1283"/>
            <p:cNvSpPr/>
            <p:nvPr/>
          </p:nvSpPr>
          <p:spPr>
            <a:xfrm>
              <a:off x="1064160" y="4041000"/>
              <a:ext cx="517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 M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Box 1284"/>
            <p:cNvSpPr/>
            <p:nvPr/>
          </p:nvSpPr>
          <p:spPr>
            <a:xfrm>
              <a:off x="1064160" y="4582440"/>
              <a:ext cx="517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5 M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Box 1285"/>
            <p:cNvSpPr/>
            <p:nvPr/>
          </p:nvSpPr>
          <p:spPr>
            <a:xfrm>
              <a:off x="1064160" y="5113440"/>
              <a:ext cx="517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0 M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Box 1286"/>
            <p:cNvSpPr/>
            <p:nvPr/>
          </p:nvSpPr>
          <p:spPr>
            <a:xfrm>
              <a:off x="1064160" y="5432040"/>
              <a:ext cx="517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3 M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7" name="AutoShape 42"/>
          <p:cNvSpPr/>
          <p:nvPr/>
        </p:nvSpPr>
        <p:spPr>
          <a:xfrm>
            <a:off x="4103640" y="942840"/>
            <a:ext cx="119160" cy="3184560"/>
          </a:xfrm>
          <a:custGeom>
            <a:avLst/>
            <a:gdLst>
              <a:gd name="textAreaLeft" fmla="*/ 17280 w 119160"/>
              <a:gd name="textAreaRight" fmla="*/ 101880 w 119160"/>
              <a:gd name="textAreaTop" fmla="*/ 17280 h 3184560"/>
              <a:gd name="textAreaBottom" fmla="*/ 3167280 h 3184560"/>
            </a:gdLst>
            <a:ahLst/>
            <a:rect l="textAreaLeft" t="textAreaTop" r="textAreaRight" b="textAreaBottom"/>
            <a:pathLst>
              <a:path w="21600" h="575588">
                <a:moveTo>
                  <a:pt x="10800" y="0"/>
                </a:moveTo>
                <a:arcTo wR="10800" hR="10800" stAng="16200000" swAng="-5400000"/>
                <a:lnTo>
                  <a:pt x="0" y="564788"/>
                </a:lnTo>
                <a:arcTo wR="10800" hR="10800" stAng="10800000" swAng="-5400000"/>
                <a:lnTo>
                  <a:pt x="10800" y="575588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AutoShape 42"/>
          <p:cNvSpPr/>
          <p:nvPr/>
        </p:nvSpPr>
        <p:spPr>
          <a:xfrm>
            <a:off x="4703760" y="942840"/>
            <a:ext cx="119160" cy="3291120"/>
          </a:xfrm>
          <a:custGeom>
            <a:avLst/>
            <a:gdLst>
              <a:gd name="textAreaLeft" fmla="*/ 17280 w 119160"/>
              <a:gd name="textAreaRight" fmla="*/ 101880 w 119160"/>
              <a:gd name="textAreaTop" fmla="*/ 17280 h 3291120"/>
              <a:gd name="textAreaBottom" fmla="*/ 3273840 h 3291120"/>
            </a:gdLst>
            <a:ahLst/>
            <a:rect l="textAreaLeft" t="textAreaTop" r="textAreaRight" b="textAreaBottom"/>
            <a:pathLst>
              <a:path w="21600" h="594846">
                <a:moveTo>
                  <a:pt x="10800" y="0"/>
                </a:moveTo>
                <a:arcTo wR="10800" hR="10800" stAng="16200000" swAng="-5400000"/>
                <a:lnTo>
                  <a:pt x="0" y="584046"/>
                </a:lnTo>
                <a:arcTo wR="10800" hR="10800" stAng="10800000" swAng="-5400000"/>
                <a:lnTo>
                  <a:pt x="10800" y="594846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AutoShape 42"/>
          <p:cNvSpPr/>
          <p:nvPr/>
        </p:nvSpPr>
        <p:spPr>
          <a:xfrm>
            <a:off x="5303880" y="942840"/>
            <a:ext cx="119160" cy="3184560"/>
          </a:xfrm>
          <a:custGeom>
            <a:avLst/>
            <a:gdLst>
              <a:gd name="textAreaLeft" fmla="*/ 17280 w 119160"/>
              <a:gd name="textAreaRight" fmla="*/ 101880 w 119160"/>
              <a:gd name="textAreaTop" fmla="*/ 17280 h 3184560"/>
              <a:gd name="textAreaBottom" fmla="*/ 3167280 h 3184560"/>
            </a:gdLst>
            <a:ahLst/>
            <a:rect l="textAreaLeft" t="textAreaTop" r="textAreaRight" b="textAreaBottom"/>
            <a:pathLst>
              <a:path w="21600" h="575588">
                <a:moveTo>
                  <a:pt x="10800" y="0"/>
                </a:moveTo>
                <a:arcTo wR="10800" hR="10800" stAng="16200000" swAng="-5400000"/>
                <a:lnTo>
                  <a:pt x="0" y="564788"/>
                </a:lnTo>
                <a:arcTo wR="10800" hR="10800" stAng="10800000" swAng="-5400000"/>
                <a:lnTo>
                  <a:pt x="10800" y="575588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AutoShape 42"/>
          <p:cNvSpPr/>
          <p:nvPr/>
        </p:nvSpPr>
        <p:spPr>
          <a:xfrm>
            <a:off x="5904000" y="942840"/>
            <a:ext cx="118800" cy="2973600"/>
          </a:xfrm>
          <a:custGeom>
            <a:avLst/>
            <a:gdLst>
              <a:gd name="textAreaLeft" fmla="*/ 17280 w 118800"/>
              <a:gd name="textAreaRight" fmla="*/ 101520 w 118800"/>
              <a:gd name="textAreaTop" fmla="*/ 17280 h 2973600"/>
              <a:gd name="textAreaBottom" fmla="*/ 2956320 h 2973600"/>
            </a:gdLst>
            <a:ahLst/>
            <a:rect l="textAreaLeft" t="textAreaTop" r="textAreaRight" b="textAreaBottom"/>
            <a:pathLst>
              <a:path w="21600" h="539086">
                <a:moveTo>
                  <a:pt x="10800" y="0"/>
                </a:moveTo>
                <a:arcTo wR="10800" hR="10800" stAng="16200000" swAng="-5400000"/>
                <a:lnTo>
                  <a:pt x="0" y="528286"/>
                </a:lnTo>
                <a:arcTo wR="10800" hR="10800" stAng="10800000" swAng="-5400000"/>
                <a:lnTo>
                  <a:pt x="10800" y="539086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AutoShape 42"/>
          <p:cNvSpPr/>
          <p:nvPr/>
        </p:nvSpPr>
        <p:spPr>
          <a:xfrm>
            <a:off x="6504120" y="942840"/>
            <a:ext cx="120600" cy="2441880"/>
          </a:xfrm>
          <a:custGeom>
            <a:avLst/>
            <a:gdLst>
              <a:gd name="textAreaLeft" fmla="*/ 17640 w 120600"/>
              <a:gd name="textAreaRight" fmla="*/ 102960 w 120600"/>
              <a:gd name="textAreaTop" fmla="*/ 17640 h 2441880"/>
              <a:gd name="textAreaBottom" fmla="*/ 2424240 h 2441880"/>
            </a:gdLst>
            <a:ahLst/>
            <a:rect l="textAreaLeft" t="textAreaTop" r="textAreaRight" b="textAreaBottom"/>
            <a:pathLst>
              <a:path w="21600" h="436114">
                <a:moveTo>
                  <a:pt x="10800" y="0"/>
                </a:moveTo>
                <a:arcTo wR="10800" hR="10800" stAng="16200000" swAng="-5400000"/>
                <a:lnTo>
                  <a:pt x="0" y="425314"/>
                </a:lnTo>
                <a:arcTo wR="10800" hR="10800" stAng="10800000" swAng="-5400000"/>
                <a:lnTo>
                  <a:pt x="10800" y="436114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AutoShape 42"/>
          <p:cNvSpPr/>
          <p:nvPr/>
        </p:nvSpPr>
        <p:spPr>
          <a:xfrm>
            <a:off x="7104240" y="942840"/>
            <a:ext cx="120600" cy="2495520"/>
          </a:xfrm>
          <a:custGeom>
            <a:avLst/>
            <a:gdLst>
              <a:gd name="textAreaLeft" fmla="*/ 17640 w 120600"/>
              <a:gd name="textAreaRight" fmla="*/ 102960 w 120600"/>
              <a:gd name="textAreaTop" fmla="*/ 17640 h 2495520"/>
              <a:gd name="textAreaBottom" fmla="*/ 2477880 h 2495520"/>
            </a:gdLst>
            <a:ahLst/>
            <a:rect l="textAreaLeft" t="textAreaTop" r="textAreaRight" b="textAreaBottom"/>
            <a:pathLst>
              <a:path w="21600" h="445693">
                <a:moveTo>
                  <a:pt x="10800" y="0"/>
                </a:moveTo>
                <a:arcTo wR="10800" hR="10800" stAng="16200000" swAng="-5400000"/>
                <a:lnTo>
                  <a:pt x="0" y="434893"/>
                </a:lnTo>
                <a:arcTo wR="10800" hR="10800" stAng="10800000" swAng="-5400000"/>
                <a:lnTo>
                  <a:pt x="10800" y="445693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AutoShape 42"/>
          <p:cNvSpPr/>
          <p:nvPr/>
        </p:nvSpPr>
        <p:spPr>
          <a:xfrm>
            <a:off x="7764480" y="942840"/>
            <a:ext cx="119160" cy="3079800"/>
          </a:xfrm>
          <a:custGeom>
            <a:avLst/>
            <a:gdLst>
              <a:gd name="textAreaLeft" fmla="*/ 17280 w 119160"/>
              <a:gd name="textAreaRight" fmla="*/ 101880 w 119160"/>
              <a:gd name="textAreaTop" fmla="*/ 17280 h 3079800"/>
              <a:gd name="textAreaBottom" fmla="*/ 3062520 h 3079800"/>
            </a:gdLst>
            <a:ahLst/>
            <a:rect l="textAreaLeft" t="textAreaTop" r="textAreaRight" b="textAreaBottom"/>
            <a:pathLst>
              <a:path w="21600" h="556655">
                <a:moveTo>
                  <a:pt x="10800" y="0"/>
                </a:moveTo>
                <a:arcTo wR="10800" hR="10800" stAng="16200000" swAng="-5400000"/>
                <a:lnTo>
                  <a:pt x="0" y="545855"/>
                </a:lnTo>
                <a:arcTo wR="10800" hR="10800" stAng="10800000" swAng="-5400000"/>
                <a:lnTo>
                  <a:pt x="10800" y="556655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AutoShape 42"/>
          <p:cNvSpPr/>
          <p:nvPr/>
        </p:nvSpPr>
        <p:spPr>
          <a:xfrm>
            <a:off x="8364600" y="942840"/>
            <a:ext cx="120600" cy="2973600"/>
          </a:xfrm>
          <a:custGeom>
            <a:avLst/>
            <a:gdLst>
              <a:gd name="textAreaLeft" fmla="*/ 17640 w 120600"/>
              <a:gd name="textAreaRight" fmla="*/ 102960 w 120600"/>
              <a:gd name="textAreaTop" fmla="*/ 17640 h 2973600"/>
              <a:gd name="textAreaBottom" fmla="*/ 2955960 h 2973600"/>
            </a:gdLst>
            <a:ahLst/>
            <a:rect l="textAreaLeft" t="textAreaTop" r="textAreaRight" b="textAreaBottom"/>
            <a:pathLst>
              <a:path w="21600" h="531064">
                <a:moveTo>
                  <a:pt x="10800" y="0"/>
                </a:moveTo>
                <a:arcTo wR="10800" hR="10800" stAng="16200000" swAng="-5400000"/>
                <a:lnTo>
                  <a:pt x="0" y="520264"/>
                </a:lnTo>
                <a:arcTo wR="10800" hR="10800" stAng="10800000" swAng="-5400000"/>
                <a:lnTo>
                  <a:pt x="10800" y="531064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矩形 3211"/>
          <p:cNvSpPr/>
          <p:nvPr/>
        </p:nvSpPr>
        <p:spPr>
          <a:xfrm>
            <a:off x="1714680" y="1420920"/>
            <a:ext cx="90360" cy="318960"/>
          </a:xfrm>
          <a:prstGeom prst="rect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矩形 3212"/>
          <p:cNvSpPr/>
          <p:nvPr/>
        </p:nvSpPr>
        <p:spPr>
          <a:xfrm>
            <a:off x="3514680" y="3067200"/>
            <a:ext cx="90360" cy="212400"/>
          </a:xfrm>
          <a:prstGeom prst="rect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矩形 3213"/>
          <p:cNvSpPr/>
          <p:nvPr/>
        </p:nvSpPr>
        <p:spPr>
          <a:xfrm>
            <a:off x="5315040" y="1357200"/>
            <a:ext cx="90360" cy="133560"/>
          </a:xfrm>
          <a:prstGeom prst="rect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矩形 3214"/>
          <p:cNvSpPr/>
          <p:nvPr/>
        </p:nvSpPr>
        <p:spPr>
          <a:xfrm>
            <a:off x="6515280" y="1442880"/>
            <a:ext cx="99720" cy="320760"/>
          </a:xfrm>
          <a:prstGeom prst="rect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Box 3215"/>
          <p:cNvSpPr/>
          <p:nvPr/>
        </p:nvSpPr>
        <p:spPr>
          <a:xfrm>
            <a:off x="5134680" y="628560"/>
            <a:ext cx="46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 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Box 3216"/>
          <p:cNvSpPr/>
          <p:nvPr/>
        </p:nvSpPr>
        <p:spPr>
          <a:xfrm>
            <a:off x="5723640" y="628560"/>
            <a:ext cx="46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 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Box 3217"/>
          <p:cNvSpPr/>
          <p:nvPr/>
        </p:nvSpPr>
        <p:spPr>
          <a:xfrm>
            <a:off x="6300000" y="628560"/>
            <a:ext cx="46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 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Box 3218"/>
          <p:cNvSpPr/>
          <p:nvPr/>
        </p:nvSpPr>
        <p:spPr>
          <a:xfrm>
            <a:off x="6913080" y="620640"/>
            <a:ext cx="53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 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3219"/>
          <p:cNvSpPr/>
          <p:nvPr/>
        </p:nvSpPr>
        <p:spPr>
          <a:xfrm>
            <a:off x="7573320" y="620640"/>
            <a:ext cx="53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 1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3220"/>
          <p:cNvSpPr/>
          <p:nvPr/>
        </p:nvSpPr>
        <p:spPr>
          <a:xfrm>
            <a:off x="8113320" y="620640"/>
            <a:ext cx="53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 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3221"/>
          <p:cNvSpPr/>
          <p:nvPr/>
        </p:nvSpPr>
        <p:spPr>
          <a:xfrm>
            <a:off x="1547640" y="620640"/>
            <a:ext cx="46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3222"/>
          <p:cNvSpPr/>
          <p:nvPr/>
        </p:nvSpPr>
        <p:spPr>
          <a:xfrm>
            <a:off x="2136600" y="620640"/>
            <a:ext cx="46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 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3223"/>
          <p:cNvSpPr/>
          <p:nvPr/>
        </p:nvSpPr>
        <p:spPr>
          <a:xfrm>
            <a:off x="2712960" y="620640"/>
            <a:ext cx="46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 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3224"/>
          <p:cNvSpPr/>
          <p:nvPr/>
        </p:nvSpPr>
        <p:spPr>
          <a:xfrm>
            <a:off x="3318480" y="620640"/>
            <a:ext cx="46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 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3225"/>
          <p:cNvSpPr/>
          <p:nvPr/>
        </p:nvSpPr>
        <p:spPr>
          <a:xfrm>
            <a:off x="3979080" y="620640"/>
            <a:ext cx="46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 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3226"/>
          <p:cNvSpPr/>
          <p:nvPr/>
        </p:nvSpPr>
        <p:spPr>
          <a:xfrm>
            <a:off x="4506840" y="620640"/>
            <a:ext cx="46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 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52"/>
          <p:cNvSpPr/>
          <p:nvPr/>
        </p:nvSpPr>
        <p:spPr>
          <a:xfrm>
            <a:off x="468360" y="2216160"/>
            <a:ext cx="3585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AutoShape 42"/>
          <p:cNvSpPr/>
          <p:nvPr/>
        </p:nvSpPr>
        <p:spPr>
          <a:xfrm>
            <a:off x="2916360" y="590400"/>
            <a:ext cx="118800" cy="3873600"/>
          </a:xfrm>
          <a:custGeom>
            <a:avLst/>
            <a:gdLst>
              <a:gd name="textAreaLeft" fmla="*/ 17280 w 118800"/>
              <a:gd name="textAreaRight" fmla="*/ 101520 w 118800"/>
              <a:gd name="textAreaTop" fmla="*/ 17280 h 3873600"/>
              <a:gd name="textAreaBottom" fmla="*/ 3856320 h 3873600"/>
            </a:gdLst>
            <a:ahLst/>
            <a:rect l="textAreaLeft" t="textAreaTop" r="textAreaRight" b="textAreaBottom"/>
            <a:pathLst>
              <a:path w="21600" h="702228">
                <a:moveTo>
                  <a:pt x="10800" y="0"/>
                </a:moveTo>
                <a:arcTo wR="10800" hR="10800" stAng="16200000" swAng="-5400000"/>
                <a:lnTo>
                  <a:pt x="0" y="691428"/>
                </a:lnTo>
                <a:arcTo wR="10800" hR="10800" stAng="10800000" swAng="-5400000"/>
                <a:lnTo>
                  <a:pt x="10800" y="702228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AutoShape 42"/>
          <p:cNvSpPr/>
          <p:nvPr/>
        </p:nvSpPr>
        <p:spPr>
          <a:xfrm>
            <a:off x="1649520" y="584280"/>
            <a:ext cx="123840" cy="4298760"/>
          </a:xfrm>
          <a:custGeom>
            <a:avLst/>
            <a:gdLst>
              <a:gd name="textAreaLeft" fmla="*/ 18000 w 123840"/>
              <a:gd name="textAreaRight" fmla="*/ 105840 w 123840"/>
              <a:gd name="textAreaTop" fmla="*/ 18000 h 4298760"/>
              <a:gd name="textAreaBottom" fmla="*/ 4280760 h 4298760"/>
            </a:gdLst>
            <a:ahLst/>
            <a:rect l="textAreaLeft" t="textAreaTop" r="textAreaRight" b="textAreaBottom"/>
            <a:pathLst>
              <a:path w="21600" h="747673">
                <a:moveTo>
                  <a:pt x="10800" y="0"/>
                </a:moveTo>
                <a:arcTo wR="10800" hR="10800" stAng="16200000" swAng="-5400000"/>
                <a:lnTo>
                  <a:pt x="0" y="736873"/>
                </a:lnTo>
                <a:arcTo wR="10800" hR="10800" stAng="10800000" swAng="-5400000"/>
                <a:lnTo>
                  <a:pt x="10800" y="747673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AutoShape 42"/>
          <p:cNvSpPr/>
          <p:nvPr/>
        </p:nvSpPr>
        <p:spPr>
          <a:xfrm>
            <a:off x="2273400" y="584280"/>
            <a:ext cx="123840" cy="3548160"/>
          </a:xfrm>
          <a:custGeom>
            <a:avLst/>
            <a:gdLst>
              <a:gd name="textAreaLeft" fmla="*/ 18000 w 123840"/>
              <a:gd name="textAreaRight" fmla="*/ 105840 w 123840"/>
              <a:gd name="textAreaTop" fmla="*/ 18000 h 3548160"/>
              <a:gd name="textAreaBottom" fmla="*/ 3530160 h 3548160"/>
            </a:gdLst>
            <a:ahLst/>
            <a:rect l="textAreaLeft" t="textAreaTop" r="textAreaRight" b="textAreaBottom"/>
            <a:pathLst>
              <a:path w="21600" h="617134">
                <a:moveTo>
                  <a:pt x="10800" y="0"/>
                </a:moveTo>
                <a:arcTo wR="10800" hR="10800" stAng="16200000" swAng="-5400000"/>
                <a:lnTo>
                  <a:pt x="0" y="606334"/>
                </a:lnTo>
                <a:arcTo wR="10800" hR="10800" stAng="10800000" swAng="-5400000"/>
                <a:lnTo>
                  <a:pt x="10800" y="617134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AutoShape 42"/>
          <p:cNvSpPr/>
          <p:nvPr/>
        </p:nvSpPr>
        <p:spPr>
          <a:xfrm>
            <a:off x="3519360" y="584280"/>
            <a:ext cx="125640" cy="3548160"/>
          </a:xfrm>
          <a:custGeom>
            <a:avLst/>
            <a:gdLst>
              <a:gd name="textAreaLeft" fmla="*/ 18360 w 125640"/>
              <a:gd name="textAreaRight" fmla="*/ 107280 w 125640"/>
              <a:gd name="textAreaTop" fmla="*/ 18360 h 3548160"/>
              <a:gd name="textAreaBottom" fmla="*/ 3529800 h 3548160"/>
            </a:gdLst>
            <a:ahLst/>
            <a:rect l="textAreaLeft" t="textAreaTop" r="textAreaRight" b="textAreaBottom"/>
            <a:pathLst>
              <a:path w="21600" h="608318">
                <a:moveTo>
                  <a:pt x="10800" y="0"/>
                </a:moveTo>
                <a:arcTo wR="10800" hR="10800" stAng="16200000" swAng="-5400000"/>
                <a:lnTo>
                  <a:pt x="0" y="597518"/>
                </a:lnTo>
                <a:arcTo wR="10800" hR="10800" stAng="10800000" swAng="-5400000"/>
                <a:lnTo>
                  <a:pt x="10800" y="608318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6" name="组合 1287"/>
          <p:cNvGrpSpPr/>
          <p:nvPr/>
        </p:nvGrpSpPr>
        <p:grpSpPr>
          <a:xfrm>
            <a:off x="971640" y="484200"/>
            <a:ext cx="549720" cy="4573080"/>
            <a:chOff x="971640" y="484200"/>
            <a:chExt cx="549720" cy="4573080"/>
          </a:xfrm>
        </p:grpSpPr>
        <p:sp>
          <p:nvSpPr>
            <p:cNvPr id="97" name="直接连接符 1261"/>
            <p:cNvSpPr/>
            <p:nvPr/>
          </p:nvSpPr>
          <p:spPr>
            <a:xfrm>
              <a:off x="971640" y="585720"/>
              <a:ext cx="0" cy="42973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直接连接符 1263"/>
            <p:cNvSpPr/>
            <p:nvPr/>
          </p:nvSpPr>
          <p:spPr>
            <a:xfrm>
              <a:off x="971640" y="583920"/>
              <a:ext cx="125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直接连接符 1265"/>
            <p:cNvSpPr/>
            <p:nvPr/>
          </p:nvSpPr>
          <p:spPr>
            <a:xfrm>
              <a:off x="971640" y="1057320"/>
              <a:ext cx="125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直接连接符 1267"/>
            <p:cNvSpPr/>
            <p:nvPr/>
          </p:nvSpPr>
          <p:spPr>
            <a:xfrm>
              <a:off x="971640" y="1569960"/>
              <a:ext cx="125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直接连接符 1268"/>
            <p:cNvSpPr/>
            <p:nvPr/>
          </p:nvSpPr>
          <p:spPr>
            <a:xfrm>
              <a:off x="987480" y="2070000"/>
              <a:ext cx="1252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直接连接符 1269"/>
            <p:cNvSpPr/>
            <p:nvPr/>
          </p:nvSpPr>
          <p:spPr>
            <a:xfrm>
              <a:off x="971640" y="2581200"/>
              <a:ext cx="1252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直接连接符 1270"/>
            <p:cNvSpPr/>
            <p:nvPr/>
          </p:nvSpPr>
          <p:spPr>
            <a:xfrm>
              <a:off x="971640" y="3083040"/>
              <a:ext cx="125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直接连接符 1271"/>
            <p:cNvSpPr/>
            <p:nvPr/>
          </p:nvSpPr>
          <p:spPr>
            <a:xfrm>
              <a:off x="971640" y="3583080"/>
              <a:ext cx="1252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直接连接符 1272"/>
            <p:cNvSpPr/>
            <p:nvPr/>
          </p:nvSpPr>
          <p:spPr>
            <a:xfrm>
              <a:off x="971640" y="4083120"/>
              <a:ext cx="125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直接连接符 1273"/>
            <p:cNvSpPr/>
            <p:nvPr/>
          </p:nvSpPr>
          <p:spPr>
            <a:xfrm>
              <a:off x="971640" y="4581720"/>
              <a:ext cx="125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直接连接符 1274"/>
            <p:cNvSpPr/>
            <p:nvPr/>
          </p:nvSpPr>
          <p:spPr>
            <a:xfrm>
              <a:off x="971640" y="4889520"/>
              <a:ext cx="1252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TextBox 1276"/>
            <p:cNvSpPr/>
            <p:nvPr/>
          </p:nvSpPr>
          <p:spPr>
            <a:xfrm>
              <a:off x="1010520" y="484200"/>
              <a:ext cx="453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 M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TextBox 1277"/>
            <p:cNvSpPr/>
            <p:nvPr/>
          </p:nvSpPr>
          <p:spPr>
            <a:xfrm>
              <a:off x="1007640" y="978120"/>
              <a:ext cx="453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 M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Box 1278"/>
            <p:cNvSpPr/>
            <p:nvPr/>
          </p:nvSpPr>
          <p:spPr>
            <a:xfrm>
              <a:off x="1003680" y="1481400"/>
              <a:ext cx="517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 M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TextBox 1280"/>
            <p:cNvSpPr/>
            <p:nvPr/>
          </p:nvSpPr>
          <p:spPr>
            <a:xfrm>
              <a:off x="1003680" y="1978200"/>
              <a:ext cx="517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5 M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TextBox 1281"/>
            <p:cNvSpPr/>
            <p:nvPr/>
          </p:nvSpPr>
          <p:spPr>
            <a:xfrm>
              <a:off x="1003680" y="2501280"/>
              <a:ext cx="517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0 M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Box 1282"/>
            <p:cNvSpPr/>
            <p:nvPr/>
          </p:nvSpPr>
          <p:spPr>
            <a:xfrm>
              <a:off x="1003680" y="3001320"/>
              <a:ext cx="517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5 M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Box 1283"/>
            <p:cNvSpPr/>
            <p:nvPr/>
          </p:nvSpPr>
          <p:spPr>
            <a:xfrm>
              <a:off x="1003680" y="3501360"/>
              <a:ext cx="517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 M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TextBox 1284"/>
            <p:cNvSpPr/>
            <p:nvPr/>
          </p:nvSpPr>
          <p:spPr>
            <a:xfrm>
              <a:off x="1003680" y="4011120"/>
              <a:ext cx="517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5 M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TextBox 1285"/>
            <p:cNvSpPr/>
            <p:nvPr/>
          </p:nvSpPr>
          <p:spPr>
            <a:xfrm>
              <a:off x="1003680" y="4511160"/>
              <a:ext cx="517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0 M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TextBox 1286"/>
            <p:cNvSpPr/>
            <p:nvPr/>
          </p:nvSpPr>
          <p:spPr>
            <a:xfrm>
              <a:off x="1003680" y="4811040"/>
              <a:ext cx="517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3 M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8" name="AutoShape 42"/>
          <p:cNvSpPr/>
          <p:nvPr/>
        </p:nvSpPr>
        <p:spPr>
          <a:xfrm>
            <a:off x="4143240" y="584280"/>
            <a:ext cx="125640" cy="2998800"/>
          </a:xfrm>
          <a:custGeom>
            <a:avLst/>
            <a:gdLst>
              <a:gd name="textAreaLeft" fmla="*/ 18360 w 125640"/>
              <a:gd name="textAreaRight" fmla="*/ 107280 w 125640"/>
              <a:gd name="textAreaTop" fmla="*/ 18360 h 2998800"/>
              <a:gd name="textAreaBottom" fmla="*/ 2980440 h 2998800"/>
            </a:gdLst>
            <a:ahLst/>
            <a:rect l="textAreaLeft" t="textAreaTop" r="textAreaRight" b="textAreaBottom"/>
            <a:pathLst>
              <a:path w="21600" h="514142">
                <a:moveTo>
                  <a:pt x="10800" y="0"/>
                </a:moveTo>
                <a:arcTo wR="10800" hR="10800" stAng="16200000" swAng="-5400000"/>
                <a:lnTo>
                  <a:pt x="0" y="503342"/>
                </a:lnTo>
                <a:arcTo wR="10800" hR="10800" stAng="10800000" swAng="-5400000"/>
                <a:lnTo>
                  <a:pt x="10800" y="514142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AutoShape 42"/>
          <p:cNvSpPr/>
          <p:nvPr/>
        </p:nvSpPr>
        <p:spPr>
          <a:xfrm>
            <a:off x="4767120" y="584280"/>
            <a:ext cx="125640" cy="3098880"/>
          </a:xfrm>
          <a:custGeom>
            <a:avLst/>
            <a:gdLst>
              <a:gd name="textAreaLeft" fmla="*/ 18360 w 125640"/>
              <a:gd name="textAreaRight" fmla="*/ 107280 w 125640"/>
              <a:gd name="textAreaTop" fmla="*/ 18360 h 3098880"/>
              <a:gd name="textAreaBottom" fmla="*/ 3080520 h 3098880"/>
            </a:gdLst>
            <a:ahLst/>
            <a:rect l="textAreaLeft" t="textAreaTop" r="textAreaRight" b="textAreaBottom"/>
            <a:pathLst>
              <a:path w="21600" h="531298">
                <a:moveTo>
                  <a:pt x="10800" y="0"/>
                </a:moveTo>
                <a:arcTo wR="10800" hR="10800" stAng="16200000" swAng="-5400000"/>
                <a:lnTo>
                  <a:pt x="0" y="520498"/>
                </a:lnTo>
                <a:arcTo wR="10800" hR="10800" stAng="10800000" swAng="-5400000"/>
                <a:lnTo>
                  <a:pt x="10800" y="531298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AutoShape 42"/>
          <p:cNvSpPr/>
          <p:nvPr/>
        </p:nvSpPr>
        <p:spPr>
          <a:xfrm>
            <a:off x="5391000" y="584280"/>
            <a:ext cx="123840" cy="2998800"/>
          </a:xfrm>
          <a:custGeom>
            <a:avLst/>
            <a:gdLst>
              <a:gd name="textAreaLeft" fmla="*/ 18000 w 123840"/>
              <a:gd name="textAreaRight" fmla="*/ 105840 w 123840"/>
              <a:gd name="textAreaTop" fmla="*/ 18000 h 2998800"/>
              <a:gd name="textAreaBottom" fmla="*/ 2980800 h 2998800"/>
            </a:gdLst>
            <a:ahLst/>
            <a:rect l="textAreaLeft" t="textAreaTop" r="textAreaRight" b="textAreaBottom"/>
            <a:pathLst>
              <a:path w="21600" h="521593">
                <a:moveTo>
                  <a:pt x="10800" y="0"/>
                </a:moveTo>
                <a:arcTo wR="10800" hR="10800" stAng="16200000" swAng="-5400000"/>
                <a:lnTo>
                  <a:pt x="0" y="510793"/>
                </a:lnTo>
                <a:arcTo wR="10800" hR="10800" stAng="10800000" swAng="-5400000"/>
                <a:lnTo>
                  <a:pt x="10800" y="521593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AutoShape 42"/>
          <p:cNvSpPr/>
          <p:nvPr/>
        </p:nvSpPr>
        <p:spPr>
          <a:xfrm>
            <a:off x="6014880" y="584280"/>
            <a:ext cx="123840" cy="2798640"/>
          </a:xfrm>
          <a:custGeom>
            <a:avLst/>
            <a:gdLst>
              <a:gd name="textAreaLeft" fmla="*/ 18000 w 123840"/>
              <a:gd name="textAreaRight" fmla="*/ 105840 w 123840"/>
              <a:gd name="textAreaTop" fmla="*/ 18000 h 2798640"/>
              <a:gd name="textAreaBottom" fmla="*/ 2780640 h 2798640"/>
            </a:gdLst>
            <a:ahLst/>
            <a:rect l="textAreaLeft" t="textAreaTop" r="textAreaRight" b="textAreaBottom"/>
            <a:pathLst>
              <a:path w="21600" h="486783">
                <a:moveTo>
                  <a:pt x="10800" y="0"/>
                </a:moveTo>
                <a:arcTo wR="10800" hR="10800" stAng="16200000" swAng="-5400000"/>
                <a:lnTo>
                  <a:pt x="0" y="475983"/>
                </a:lnTo>
                <a:arcTo wR="10800" hR="10800" stAng="10800000" swAng="-5400000"/>
                <a:lnTo>
                  <a:pt x="10800" y="486783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AutoShape 42"/>
          <p:cNvSpPr/>
          <p:nvPr/>
        </p:nvSpPr>
        <p:spPr>
          <a:xfrm>
            <a:off x="6637320" y="584280"/>
            <a:ext cx="125280" cy="2298600"/>
          </a:xfrm>
          <a:custGeom>
            <a:avLst/>
            <a:gdLst>
              <a:gd name="textAreaLeft" fmla="*/ 18360 w 125280"/>
              <a:gd name="textAreaRight" fmla="*/ 106920 w 125280"/>
              <a:gd name="textAreaTop" fmla="*/ 18360 h 2298600"/>
              <a:gd name="textAreaBottom" fmla="*/ 2280240 h 2298600"/>
            </a:gdLst>
            <a:ahLst/>
            <a:rect l="textAreaLeft" t="textAreaTop" r="textAreaRight" b="textAreaBottom"/>
            <a:pathLst>
              <a:path w="21600" h="395237">
                <a:moveTo>
                  <a:pt x="10800" y="0"/>
                </a:moveTo>
                <a:arcTo wR="10800" hR="10800" stAng="16200000" swAng="-5400000"/>
                <a:lnTo>
                  <a:pt x="0" y="384437"/>
                </a:lnTo>
                <a:arcTo wR="10800" hR="10800" stAng="10800000" swAng="-5400000"/>
                <a:lnTo>
                  <a:pt x="10800" y="395237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AutoShape 42"/>
          <p:cNvSpPr/>
          <p:nvPr/>
        </p:nvSpPr>
        <p:spPr>
          <a:xfrm>
            <a:off x="7261200" y="584280"/>
            <a:ext cx="125280" cy="2349360"/>
          </a:xfrm>
          <a:custGeom>
            <a:avLst/>
            <a:gdLst>
              <a:gd name="textAreaLeft" fmla="*/ 18360 w 125280"/>
              <a:gd name="textAreaRight" fmla="*/ 106920 w 125280"/>
              <a:gd name="textAreaTop" fmla="*/ 18360 h 2349360"/>
              <a:gd name="textAreaBottom" fmla="*/ 2331000 h 2349360"/>
            </a:gdLst>
            <a:ahLst/>
            <a:rect l="textAreaLeft" t="textAreaTop" r="textAreaRight" b="textAreaBottom"/>
            <a:pathLst>
              <a:path w="21600" h="403963">
                <a:moveTo>
                  <a:pt x="10800" y="0"/>
                </a:moveTo>
                <a:arcTo wR="10800" hR="10800" stAng="16200000" swAng="-5400000"/>
                <a:lnTo>
                  <a:pt x="0" y="393163"/>
                </a:lnTo>
                <a:arcTo wR="10800" hR="10800" stAng="10800000" swAng="-5400000"/>
                <a:lnTo>
                  <a:pt x="10800" y="403963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AutoShape 42"/>
          <p:cNvSpPr/>
          <p:nvPr/>
        </p:nvSpPr>
        <p:spPr>
          <a:xfrm>
            <a:off x="7947000" y="584280"/>
            <a:ext cx="125280" cy="2898720"/>
          </a:xfrm>
          <a:custGeom>
            <a:avLst/>
            <a:gdLst>
              <a:gd name="textAreaLeft" fmla="*/ 18360 w 125280"/>
              <a:gd name="textAreaRight" fmla="*/ 106920 w 125280"/>
              <a:gd name="textAreaTop" fmla="*/ 18360 h 2898720"/>
              <a:gd name="textAreaBottom" fmla="*/ 2880360 h 2898720"/>
            </a:gdLst>
            <a:ahLst/>
            <a:rect l="textAreaLeft" t="textAreaTop" r="textAreaRight" b="textAreaBottom"/>
            <a:pathLst>
              <a:path w="21600" h="498409">
                <a:moveTo>
                  <a:pt x="10800" y="0"/>
                </a:moveTo>
                <a:arcTo wR="10800" hR="10800" stAng="16200000" swAng="-5400000"/>
                <a:lnTo>
                  <a:pt x="0" y="487609"/>
                </a:lnTo>
                <a:arcTo wR="10800" hR="10800" stAng="10800000" swAng="-5400000"/>
                <a:lnTo>
                  <a:pt x="10800" y="498409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AutoShape 42"/>
          <p:cNvSpPr/>
          <p:nvPr/>
        </p:nvSpPr>
        <p:spPr>
          <a:xfrm>
            <a:off x="8570880" y="584280"/>
            <a:ext cx="125280" cy="2798640"/>
          </a:xfrm>
          <a:custGeom>
            <a:avLst/>
            <a:gdLst>
              <a:gd name="textAreaLeft" fmla="*/ 18360 w 125280"/>
              <a:gd name="textAreaRight" fmla="*/ 106920 w 125280"/>
              <a:gd name="textAreaTop" fmla="*/ 18360 h 2798640"/>
              <a:gd name="textAreaBottom" fmla="*/ 2780280 h 2798640"/>
            </a:gdLst>
            <a:ahLst/>
            <a:rect l="textAreaLeft" t="textAreaTop" r="textAreaRight" b="textAreaBottom"/>
            <a:pathLst>
              <a:path w="21600" h="481203">
                <a:moveTo>
                  <a:pt x="10800" y="0"/>
                </a:moveTo>
                <a:arcTo wR="10800" hR="10800" stAng="16200000" swAng="-5400000"/>
                <a:lnTo>
                  <a:pt x="0" y="470403"/>
                </a:lnTo>
                <a:arcTo wR="10800" hR="10800" stAng="10800000" swAng="-5400000"/>
                <a:lnTo>
                  <a:pt x="10800" y="481203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Box 35"/>
          <p:cNvSpPr/>
          <p:nvPr/>
        </p:nvSpPr>
        <p:spPr>
          <a:xfrm>
            <a:off x="5249520" y="263520"/>
            <a:ext cx="46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 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Box 36"/>
          <p:cNvSpPr/>
          <p:nvPr/>
        </p:nvSpPr>
        <p:spPr>
          <a:xfrm>
            <a:off x="5860800" y="263520"/>
            <a:ext cx="46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 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Box 37"/>
          <p:cNvSpPr/>
          <p:nvPr/>
        </p:nvSpPr>
        <p:spPr>
          <a:xfrm>
            <a:off x="6459480" y="263520"/>
            <a:ext cx="46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 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Box 38"/>
          <p:cNvSpPr/>
          <p:nvPr/>
        </p:nvSpPr>
        <p:spPr>
          <a:xfrm>
            <a:off x="7099560" y="263520"/>
            <a:ext cx="53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 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Box 39"/>
          <p:cNvSpPr/>
          <p:nvPr/>
        </p:nvSpPr>
        <p:spPr>
          <a:xfrm>
            <a:off x="7786080" y="263520"/>
            <a:ext cx="53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 1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Box 40"/>
          <p:cNvSpPr/>
          <p:nvPr/>
        </p:nvSpPr>
        <p:spPr>
          <a:xfrm>
            <a:off x="8347320" y="263520"/>
            <a:ext cx="53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 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Box 41"/>
          <p:cNvSpPr/>
          <p:nvPr/>
        </p:nvSpPr>
        <p:spPr>
          <a:xfrm>
            <a:off x="1497600" y="260280"/>
            <a:ext cx="46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Box 42"/>
          <p:cNvSpPr/>
          <p:nvPr/>
        </p:nvSpPr>
        <p:spPr>
          <a:xfrm>
            <a:off x="2109600" y="260280"/>
            <a:ext cx="46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 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Box 43"/>
          <p:cNvSpPr/>
          <p:nvPr/>
        </p:nvSpPr>
        <p:spPr>
          <a:xfrm>
            <a:off x="2707920" y="260280"/>
            <a:ext cx="46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 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Box 44"/>
          <p:cNvSpPr/>
          <p:nvPr/>
        </p:nvSpPr>
        <p:spPr>
          <a:xfrm>
            <a:off x="3337560" y="257040"/>
            <a:ext cx="46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 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Box 45"/>
          <p:cNvSpPr/>
          <p:nvPr/>
        </p:nvSpPr>
        <p:spPr>
          <a:xfrm>
            <a:off x="4024080" y="257040"/>
            <a:ext cx="46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 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Box 46"/>
          <p:cNvSpPr/>
          <p:nvPr/>
        </p:nvSpPr>
        <p:spPr>
          <a:xfrm>
            <a:off x="4584600" y="257040"/>
            <a:ext cx="46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r 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矩形 47"/>
          <p:cNvSpPr/>
          <p:nvPr/>
        </p:nvSpPr>
        <p:spPr>
          <a:xfrm>
            <a:off x="2906640" y="1362240"/>
            <a:ext cx="136440" cy="10296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矩形 48"/>
          <p:cNvSpPr/>
          <p:nvPr/>
        </p:nvSpPr>
        <p:spPr>
          <a:xfrm>
            <a:off x="5383080" y="893880"/>
            <a:ext cx="136800" cy="20160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0" name="组合 53"/>
          <p:cNvGrpSpPr/>
          <p:nvPr/>
        </p:nvGrpSpPr>
        <p:grpSpPr>
          <a:xfrm>
            <a:off x="5580000" y="4335480"/>
            <a:ext cx="2183400" cy="626760"/>
            <a:chOff x="5580000" y="4335480"/>
            <a:chExt cx="2183400" cy="626760"/>
          </a:xfrm>
        </p:grpSpPr>
        <p:sp>
          <p:nvSpPr>
            <p:cNvPr id="141" name="矩形 49"/>
            <p:cNvSpPr/>
            <p:nvPr/>
          </p:nvSpPr>
          <p:spPr>
            <a:xfrm>
              <a:off x="5580000" y="4406760"/>
              <a:ext cx="428400" cy="142920"/>
            </a:xfrm>
            <a:prstGeom prst="rect">
              <a:avLst/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矩形 50"/>
            <p:cNvSpPr/>
            <p:nvPr/>
          </p:nvSpPr>
          <p:spPr>
            <a:xfrm>
              <a:off x="5580000" y="4662720"/>
              <a:ext cx="428400" cy="14292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TextBox 51"/>
            <p:cNvSpPr/>
            <p:nvPr/>
          </p:nvSpPr>
          <p:spPr>
            <a:xfrm>
              <a:off x="6154560" y="4335480"/>
              <a:ext cx="1608840" cy="626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H63 homozygou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2428 homozyguo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4" name="矩形 52"/>
          <p:cNvSpPr/>
          <p:nvPr/>
        </p:nvSpPr>
        <p:spPr>
          <a:xfrm>
            <a:off x="1835280" y="6021360"/>
            <a:ext cx="6858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 S1. Graphic genotypes of the two ILs, DQ28 (A) and DQ438 (B) selected from MH63- and 02428-ILs, respectively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Box 55"/>
          <p:cNvSpPr/>
          <p:nvPr/>
        </p:nvSpPr>
        <p:spPr>
          <a:xfrm>
            <a:off x="324000" y="1927080"/>
            <a:ext cx="360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7-21T00:12:50Z</dcterms:created>
  <dc:creator>邱先进</dc:creator>
  <dc:description/>
  <dc:language>en-US</dc:language>
  <cp:lastModifiedBy>Microsoft</cp:lastModifiedBy>
  <dcterms:modified xsi:type="dcterms:W3CDTF">2016-10-18T13:04:53Z</dcterms:modified>
  <cp:revision>15</cp:revision>
  <dc:subject/>
  <dc:title>幻灯片 1</dc:title>
</cp:coreProperties>
</file>